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14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3330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2821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5685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67957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3178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6500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9026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4799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8903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1173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3830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822251-048C-473E-97EE-9D409FD8275E}" type="datetimeFigureOut">
              <a:rPr lang="fr-FR" smtClean="0"/>
              <a:t>16/01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6618EC-7614-41D8-BDD3-5EF29E12179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343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2"/>
          <a:srcRect l="27828" t="18962" r="18506" b="16667"/>
          <a:stretch/>
        </p:blipFill>
        <p:spPr>
          <a:xfrm rot="15829437" flipH="1">
            <a:off x="2262643" y="-264728"/>
            <a:ext cx="2080828" cy="4334973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403694" y="2502878"/>
            <a:ext cx="5157429" cy="7233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Rectangle 13"/>
          <p:cNvSpPr/>
          <p:nvPr/>
        </p:nvSpPr>
        <p:spPr>
          <a:xfrm>
            <a:off x="805395" y="1160059"/>
            <a:ext cx="809533" cy="16793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Rectangle 14"/>
          <p:cNvSpPr/>
          <p:nvPr/>
        </p:nvSpPr>
        <p:spPr>
          <a:xfrm>
            <a:off x="4349889" y="1161445"/>
            <a:ext cx="1262492" cy="15590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Rectangle 15"/>
          <p:cNvSpPr/>
          <p:nvPr/>
        </p:nvSpPr>
        <p:spPr>
          <a:xfrm>
            <a:off x="1013698" y="540454"/>
            <a:ext cx="5157429" cy="10175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ZoneTexte 16"/>
          <p:cNvSpPr txBox="1"/>
          <p:nvPr/>
        </p:nvSpPr>
        <p:spPr>
          <a:xfrm>
            <a:off x="1647084" y="1241942"/>
            <a:ext cx="29568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smtClean="0"/>
              <a:t>A             B          C             D            E</a:t>
            </a:r>
            <a:endParaRPr lang="fr-FR" sz="1400" dirty="0"/>
          </a:p>
        </p:txBody>
      </p:sp>
      <p:sp>
        <p:nvSpPr>
          <p:cNvPr id="18" name="Rectangle 17"/>
          <p:cNvSpPr/>
          <p:nvPr/>
        </p:nvSpPr>
        <p:spPr>
          <a:xfrm>
            <a:off x="1559935" y="2184647"/>
            <a:ext cx="2951907" cy="47022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ZoneTexte 18"/>
          <p:cNvSpPr txBox="1"/>
          <p:nvPr/>
        </p:nvSpPr>
        <p:spPr>
          <a:xfrm>
            <a:off x="1645480" y="2145286"/>
            <a:ext cx="2956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-          +       -          -          +</a:t>
            </a:r>
            <a:endParaRPr lang="fr-FR" dirty="0"/>
          </a:p>
        </p:txBody>
      </p:sp>
      <p:sp>
        <p:nvSpPr>
          <p:cNvPr id="2" name="Rectangle 1"/>
          <p:cNvSpPr/>
          <p:nvPr/>
        </p:nvSpPr>
        <p:spPr>
          <a:xfrm>
            <a:off x="4904905" y="913829"/>
            <a:ext cx="6820562" cy="20036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Latex </a:t>
            </a:r>
            <a:r>
              <a:rPr lang="en-US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agglutination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sults for serum sample no. 2086 from flock 1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following antigens were included: (A)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hpC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BPSS0492), (B) a common lipopolysaccharide antigen from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 pseudomallei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ailandensis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(C) rare LPS from serotype B </a:t>
            </a:r>
            <a:r>
              <a:rPr lang="en-US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pseudomallei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Most samples are expected to be negative), (D)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no-heptos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PS, (E) Hcp1. Positive results are identified by a “+” sign.</a:t>
            </a:r>
            <a:endParaRPr lang="fr-FR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80685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96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ANS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ROUCAU Karine</dc:creator>
  <cp:lastModifiedBy>LAROUCAU Karine</cp:lastModifiedBy>
  <cp:revision>3</cp:revision>
  <dcterms:created xsi:type="dcterms:W3CDTF">2022-08-19T13:12:32Z</dcterms:created>
  <dcterms:modified xsi:type="dcterms:W3CDTF">2024-01-16T10:41:46Z</dcterms:modified>
</cp:coreProperties>
</file>